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271"/>
  </p:normalViewPr>
  <p:slideViewPr>
    <p:cSldViewPr snapToGrid="0" snapToObjects="1">
      <p:cViewPr varScale="1">
        <p:scale>
          <a:sx n="85" d="100"/>
          <a:sy n="85" d="100"/>
        </p:scale>
        <p:origin x="208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F1B046-3FD0-6A44-9DD9-86225EC21FCD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9748B5-ED3F-F24D-A42F-ADE4C2194C3E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03343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a-DK" dirty="0"/>
              <a:t>UDEN 55140</a:t>
            </a:r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F56EC-0152-EF4B-9D48-703E8F5B292E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63616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E36AEE-0AAE-EB46-8585-BFA8A53E1C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448D3CAB-F928-F443-B70B-A4A069C344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8FBE94BD-44CA-E542-B676-2A4864F1D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520E879F-6143-8E45-B42C-63DA0AADE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3BC9263-12E6-7245-8794-FA56D5917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39582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DA202-7DCD-2E4D-BA9D-CA9CB17B1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E7655361-7AAB-1F4F-ADBA-E5908DC395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084EE0E-27F2-1843-B201-63B2D8218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0FF55214-2021-1045-9B96-466B9C901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E3A5CAC4-63EE-D549-A53F-0DF269017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00182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CE9E42D7-6406-794A-913F-7288FD6879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F5FF2968-C1EE-6346-9349-8F386BC059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A8282F1-198B-0242-BB4E-42FA5EC417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A5AB7F0-8C7F-064E-A269-A8701E11D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CFFBC76-7B5F-4448-8B8E-BBAFAE352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79533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3585F6-368F-7340-B24A-674DF0434D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19790D37-8B95-5C43-9AB1-7EDF44A46C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5C1157D-4D13-8040-B9A8-11C76A07B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F41149DB-CDD4-7A46-BDB1-1CE5FD832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0EB0A6FE-D8B8-CF40-B79A-C3B9B2BAF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967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78EB12-EB4C-D346-A173-39B10FB41F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F79DB526-4695-9C4F-B8D0-63B8B3972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B890B13A-F68C-064A-B8F5-9CE277871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28FA81AE-B100-7841-9202-2CF2D494D1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C8A6E880-F31B-1343-A288-6F44A630C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60053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C48DCF-E601-7E45-87A3-3A65AAC899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5AEF081E-1DC5-D14B-8FC3-69B3A3B25A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36769C43-FA8E-4E4E-9AF0-50A57CF94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03D1830C-9207-6945-900C-24B13EF31B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D3D4A98D-CB3A-5442-A1EE-234E23AC8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712FA554-8C32-5545-8858-0B1ACEB98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41530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D38803F-B7DC-024D-9055-895194F91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B2F4A049-9DF1-164D-A220-D33DBC2E47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96D07919-7C5F-124D-B924-54C5B5DBE3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015E776D-EA88-5049-87CB-60412DF3E3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6AFAC41B-88F9-A84D-9498-88E9F2338D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520D017E-4DE6-9F4F-88DA-0B0E360B4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E78FF8DF-9AC4-FF47-B77E-F181E7FF9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B27F67F3-32FD-CB4A-A335-F98B1C2D8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56172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CD56E83-B6E9-0440-AEC3-BF50F3B6DF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ACD8D50D-6DC6-4D45-8C3C-D91FAA23D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ABFC4075-B59D-E34D-BDC4-E94EDF33D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DA3AFD63-B0F7-4F42-B3AD-9AE0CD69E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631262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63B36918-31C1-A94D-BC45-E148793E9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8FE4C342-3A05-0448-8E67-D1FEF5AE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7E5700FD-9340-3543-ADF3-095E97673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0239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2A0918-A1F6-314F-807D-1DACD9599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0A2B63AB-4503-6248-B9D9-8B922AD85A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A65871FD-FB1A-034F-AA5C-E332A8BFE0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C5ACDDFA-2B88-434D-B6CA-103D383DD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D0F1F653-F76D-154B-BD45-75B010491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77912D9A-2DBD-B342-8E54-336BADE87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7343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2ACD7B-E74F-654B-8A17-80EEA54C3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AF03CC90-E036-5E46-9269-E25753E10F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A5D0C92D-C3D8-0B41-88FE-25CB72A671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168795A9-784A-C945-A82B-8F02E24C2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B90EF723-7D4B-6546-81B2-DEAF22FC4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B34434CD-6504-534D-BB1D-45CA6B8DF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9167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31FF67E6-C11F-7342-AE86-6D055E8D92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1E9315E8-8DA9-B04C-B7CF-E5D2C94D1A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da-DK"/>
              <a:t>Rediger teksttypografien i masteren
Andet niveau
Tredje niveau
Fjerde niveau
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4907B1C-2DD5-FD4F-B76E-6F5D9DB4AB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8E261-3294-4B4F-B6F0-D9A65EC5F82C}" type="datetimeFigureOut">
              <a:rPr lang="da-DK" smtClean="0"/>
              <a:t>24.05.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193BE957-9803-054B-899D-B9160B6291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D3C0F25-7517-574F-9E85-3455025306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A772A-AF43-5044-93F1-C988FC6CCE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92105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lede 2">
            <a:extLst>
              <a:ext uri="{FF2B5EF4-FFF2-40B4-BE49-F238E27FC236}">
                <a16:creationId xmlns:a16="http://schemas.microsoft.com/office/drawing/2014/main" id="{4C86C5EE-2310-784D-AF66-B89FDC96A4C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46" b="4948"/>
          <a:stretch/>
        </p:blipFill>
        <p:spPr>
          <a:xfrm>
            <a:off x="3368786" y="1135117"/>
            <a:ext cx="5004730" cy="3913949"/>
          </a:xfrm>
          <a:prstGeom prst="rect">
            <a:avLst/>
          </a:prstGeom>
        </p:spPr>
      </p:pic>
      <p:sp>
        <p:nvSpPr>
          <p:cNvPr id="5" name="Tekstfelt 4">
            <a:extLst>
              <a:ext uri="{FF2B5EF4-FFF2-40B4-BE49-F238E27FC236}">
                <a16:creationId xmlns:a16="http://schemas.microsoft.com/office/drawing/2014/main" id="{735447C5-668F-1B40-83CA-566F59DB4A90}"/>
              </a:ext>
            </a:extLst>
          </p:cNvPr>
          <p:cNvSpPr txBox="1"/>
          <p:nvPr/>
        </p:nvSpPr>
        <p:spPr>
          <a:xfrm rot="16200000">
            <a:off x="1647891" y="3049168"/>
            <a:ext cx="2595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Striatal 5-HT</a:t>
            </a:r>
            <a:r>
              <a:rPr lang="en-GB" b="1" baseline="-25000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4</a:t>
            </a:r>
            <a:r>
              <a:rPr lang="en-GB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R BP</a:t>
            </a:r>
            <a:r>
              <a:rPr lang="en-GB" b="1" baseline="-25000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495FD658-47F0-674E-A88B-BDFC1556F92A}"/>
              </a:ext>
            </a:extLst>
          </p:cNvPr>
          <p:cNvSpPr txBox="1"/>
          <p:nvPr/>
        </p:nvSpPr>
        <p:spPr>
          <a:xfrm>
            <a:off x="6889024" y="5529677"/>
            <a:ext cx="4780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rgbClr val="33A12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♂</a:t>
            </a:r>
          </a:p>
        </p:txBody>
      </p:sp>
      <p:sp>
        <p:nvSpPr>
          <p:cNvPr id="11" name="Tekstfelt 10">
            <a:extLst>
              <a:ext uri="{FF2B5EF4-FFF2-40B4-BE49-F238E27FC236}">
                <a16:creationId xmlns:a16="http://schemas.microsoft.com/office/drawing/2014/main" id="{5214CD13-F782-9544-9F65-52CCB74E1A03}"/>
              </a:ext>
            </a:extLst>
          </p:cNvPr>
          <p:cNvSpPr txBox="1"/>
          <p:nvPr/>
        </p:nvSpPr>
        <p:spPr>
          <a:xfrm>
            <a:off x="4557799" y="5508414"/>
            <a:ext cx="38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rgbClr val="1F78B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♀</a:t>
            </a:r>
          </a:p>
        </p:txBody>
      </p:sp>
      <p:sp>
        <p:nvSpPr>
          <p:cNvPr id="12" name="Tekstfelt 11">
            <a:extLst>
              <a:ext uri="{FF2B5EF4-FFF2-40B4-BE49-F238E27FC236}">
                <a16:creationId xmlns:a16="http://schemas.microsoft.com/office/drawing/2014/main" id="{C27D2B00-EA6E-6F41-8870-D9816D6EAAF6}"/>
              </a:ext>
            </a:extLst>
          </p:cNvPr>
          <p:cNvSpPr txBox="1"/>
          <p:nvPr/>
        </p:nvSpPr>
        <p:spPr>
          <a:xfrm>
            <a:off x="5945593" y="5511320"/>
            <a:ext cx="9820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Sexual dysfunction</a:t>
            </a:r>
          </a:p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 = 8</a:t>
            </a:r>
          </a:p>
          <a:p>
            <a:endParaRPr lang="en-GB" sz="1100" b="1" dirty="0">
              <a:latin typeface="Arial" panose="020B0604020202020204" pitchFamily="34" charset="0"/>
              <a:ea typeface="Palatino" pitchFamily="2" charset="77"/>
              <a:cs typeface="Arial" panose="020B0604020202020204" pitchFamily="34" charset="0"/>
            </a:endParaRPr>
          </a:p>
        </p:txBody>
      </p:sp>
      <p:sp>
        <p:nvSpPr>
          <p:cNvPr id="13" name="Tekstfelt 12">
            <a:extLst>
              <a:ext uri="{FF2B5EF4-FFF2-40B4-BE49-F238E27FC236}">
                <a16:creationId xmlns:a16="http://schemas.microsoft.com/office/drawing/2014/main" id="{24C009FF-19C5-184C-9231-AB1B30C3F03A}"/>
              </a:ext>
            </a:extLst>
          </p:cNvPr>
          <p:cNvSpPr txBox="1"/>
          <p:nvPr/>
        </p:nvSpPr>
        <p:spPr>
          <a:xfrm>
            <a:off x="7328505" y="5487694"/>
            <a:ext cx="101156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ormal sexual function</a:t>
            </a:r>
          </a:p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 = 17</a:t>
            </a:r>
          </a:p>
        </p:txBody>
      </p:sp>
      <p:sp>
        <p:nvSpPr>
          <p:cNvPr id="14" name="Tekstfelt 13">
            <a:extLst>
              <a:ext uri="{FF2B5EF4-FFF2-40B4-BE49-F238E27FC236}">
                <a16:creationId xmlns:a16="http://schemas.microsoft.com/office/drawing/2014/main" id="{EB1E126D-4C74-AE47-9942-AC9390A528B4}"/>
              </a:ext>
            </a:extLst>
          </p:cNvPr>
          <p:cNvSpPr txBox="1"/>
          <p:nvPr/>
        </p:nvSpPr>
        <p:spPr>
          <a:xfrm>
            <a:off x="4792283" y="5480846"/>
            <a:ext cx="101156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ormal sexual function</a:t>
            </a:r>
          </a:p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 = 14</a:t>
            </a:r>
          </a:p>
        </p:txBody>
      </p:sp>
      <p:sp>
        <p:nvSpPr>
          <p:cNvPr id="15" name="Tekstfelt 14">
            <a:extLst>
              <a:ext uri="{FF2B5EF4-FFF2-40B4-BE49-F238E27FC236}">
                <a16:creationId xmlns:a16="http://schemas.microsoft.com/office/drawing/2014/main" id="{B6B99A58-50FC-AB4F-B5B9-EE50D6B6F969}"/>
              </a:ext>
            </a:extLst>
          </p:cNvPr>
          <p:cNvSpPr txBox="1"/>
          <p:nvPr/>
        </p:nvSpPr>
        <p:spPr>
          <a:xfrm>
            <a:off x="3642182" y="5498973"/>
            <a:ext cx="98548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Sexual dysfunction</a:t>
            </a:r>
          </a:p>
          <a:p>
            <a:pPr algn="ctr"/>
            <a:r>
              <a:rPr lang="en-GB" sz="1100" b="1" dirty="0"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n = 46</a:t>
            </a:r>
          </a:p>
        </p:txBody>
      </p:sp>
      <p:sp>
        <p:nvSpPr>
          <p:cNvPr id="18" name="Venstre klammeparentes 17">
            <a:extLst>
              <a:ext uri="{FF2B5EF4-FFF2-40B4-BE49-F238E27FC236}">
                <a16:creationId xmlns:a16="http://schemas.microsoft.com/office/drawing/2014/main" id="{7009D8C5-7400-8E4A-AF5C-6F80B2714EE8}"/>
              </a:ext>
            </a:extLst>
          </p:cNvPr>
          <p:cNvSpPr/>
          <p:nvPr/>
        </p:nvSpPr>
        <p:spPr>
          <a:xfrm rot="5400000">
            <a:off x="6909725" y="1624824"/>
            <a:ext cx="361898" cy="769636"/>
          </a:xfrm>
          <a:prstGeom prst="leftBrace">
            <a:avLst/>
          </a:prstGeom>
          <a:ln w="28575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kstfelt 118">
            <a:extLst>
              <a:ext uri="{FF2B5EF4-FFF2-40B4-BE49-F238E27FC236}">
                <a16:creationId xmlns:a16="http://schemas.microsoft.com/office/drawing/2014/main" id="{76563CB1-9B0A-FC46-A0D8-FC4899820DE2}"/>
              </a:ext>
            </a:extLst>
          </p:cNvPr>
          <p:cNvSpPr txBox="1"/>
          <p:nvPr/>
        </p:nvSpPr>
        <p:spPr>
          <a:xfrm>
            <a:off x="6726091" y="1494448"/>
            <a:ext cx="928090" cy="47466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da-DK" sz="1600" b="1" dirty="0">
                <a:effectLst/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p.adj=1</a:t>
            </a:r>
            <a:endParaRPr lang="da-DK" sz="2400" dirty="0">
              <a:effectLst/>
              <a:latin typeface="Arial" panose="020B0604020202020204" pitchFamily="34" charset="0"/>
              <a:ea typeface="Palatino" pitchFamily="2" charset="77"/>
              <a:cs typeface="Arial" panose="020B0604020202020204" pitchFamily="34" charset="0"/>
            </a:endParaRPr>
          </a:p>
        </p:txBody>
      </p:sp>
      <p:sp>
        <p:nvSpPr>
          <p:cNvPr id="20" name="Venstre klammeparentes 19">
            <a:extLst>
              <a:ext uri="{FF2B5EF4-FFF2-40B4-BE49-F238E27FC236}">
                <a16:creationId xmlns:a16="http://schemas.microsoft.com/office/drawing/2014/main" id="{B70850E0-C235-C24C-A391-1954861FC90B}"/>
              </a:ext>
            </a:extLst>
          </p:cNvPr>
          <p:cNvSpPr/>
          <p:nvPr/>
        </p:nvSpPr>
        <p:spPr>
          <a:xfrm rot="5400000">
            <a:off x="4560802" y="1624824"/>
            <a:ext cx="361898" cy="769636"/>
          </a:xfrm>
          <a:prstGeom prst="leftBrace">
            <a:avLst/>
          </a:prstGeom>
          <a:ln w="28575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a-DK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kstfelt 118">
            <a:extLst>
              <a:ext uri="{FF2B5EF4-FFF2-40B4-BE49-F238E27FC236}">
                <a16:creationId xmlns:a16="http://schemas.microsoft.com/office/drawing/2014/main" id="{BD5C07D7-6676-3344-A973-EBC7AFA01ABB}"/>
              </a:ext>
            </a:extLst>
          </p:cNvPr>
          <p:cNvSpPr txBox="1"/>
          <p:nvPr/>
        </p:nvSpPr>
        <p:spPr>
          <a:xfrm>
            <a:off x="4079122" y="1494448"/>
            <a:ext cx="1287144" cy="47466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da-DK" sz="1600" b="1" dirty="0">
                <a:effectLst/>
                <a:latin typeface="Arial" panose="020B0604020202020204" pitchFamily="34" charset="0"/>
                <a:ea typeface="Palatino" pitchFamily="2" charset="77"/>
                <a:cs typeface="Arial" panose="020B0604020202020204" pitchFamily="34" charset="0"/>
              </a:rPr>
              <a:t>p.adj=0.018</a:t>
            </a:r>
            <a:endParaRPr lang="da-DK" sz="2400" dirty="0">
              <a:effectLst/>
              <a:latin typeface="Arial" panose="020B0604020202020204" pitchFamily="34" charset="0"/>
              <a:ea typeface="Palatino" pitchFamily="2" charset="77"/>
              <a:cs typeface="Arial" panose="020B0604020202020204" pitchFamily="34" charset="0"/>
            </a:endParaRPr>
          </a:p>
        </p:txBody>
      </p:sp>
      <p:sp>
        <p:nvSpPr>
          <p:cNvPr id="29" name="Tekstfelt 130">
            <a:extLst>
              <a:ext uri="{FF2B5EF4-FFF2-40B4-BE49-F238E27FC236}">
                <a16:creationId xmlns:a16="http://schemas.microsoft.com/office/drawing/2014/main" id="{232EE954-A401-AF4D-BA42-83B3E0A5382A}"/>
              </a:ext>
            </a:extLst>
          </p:cNvPr>
          <p:cNvSpPr txBox="1"/>
          <p:nvPr/>
        </p:nvSpPr>
        <p:spPr>
          <a:xfrm>
            <a:off x="3927497" y="799792"/>
            <a:ext cx="4106646" cy="429146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da-DK" sz="3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RATIFIED ON SEX</a:t>
            </a:r>
            <a:endParaRPr lang="da-DK" sz="3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8" name="Venstre klammeparentes 7">
            <a:extLst>
              <a:ext uri="{FF2B5EF4-FFF2-40B4-BE49-F238E27FC236}">
                <a16:creationId xmlns:a16="http://schemas.microsoft.com/office/drawing/2014/main" id="{0D844161-4C99-5747-B45A-16DBEA5F5059}"/>
              </a:ext>
            </a:extLst>
          </p:cNvPr>
          <p:cNvSpPr/>
          <p:nvPr/>
        </p:nvSpPr>
        <p:spPr>
          <a:xfrm rot="16200000">
            <a:off x="6938264" y="4259000"/>
            <a:ext cx="318784" cy="205920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Venstre klammeparentes 8">
            <a:extLst>
              <a:ext uri="{FF2B5EF4-FFF2-40B4-BE49-F238E27FC236}">
                <a16:creationId xmlns:a16="http://schemas.microsoft.com/office/drawing/2014/main" id="{779142E3-5965-CC42-AAAE-59653844D9C9}"/>
              </a:ext>
            </a:extLst>
          </p:cNvPr>
          <p:cNvSpPr/>
          <p:nvPr/>
        </p:nvSpPr>
        <p:spPr>
          <a:xfrm rot="16200000">
            <a:off x="4583649" y="4259809"/>
            <a:ext cx="320400" cy="205920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355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Macintosh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</vt:lpstr>
      <vt:lpstr>Times New Roman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Annika Læbo Rasmussen</dc:creator>
  <cp:lastModifiedBy>Annika Læbo Rasmussen</cp:lastModifiedBy>
  <cp:revision>1</cp:revision>
  <dcterms:created xsi:type="dcterms:W3CDTF">2023-05-24T19:54:21Z</dcterms:created>
  <dcterms:modified xsi:type="dcterms:W3CDTF">2023-05-24T19:54:46Z</dcterms:modified>
</cp:coreProperties>
</file>